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115"/>
    <p:restoredTop sz="94660"/>
  </p:normalViewPr>
  <p:slideViewPr>
    <p:cSldViewPr snapToGrid="0" snapToObjects="1">
      <p:cViewPr varScale="1">
        <p:scale>
          <a:sx n="118" d="100"/>
          <a:sy n="118" d="100"/>
        </p:scale>
        <p:origin x="456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salvatoreesposito/GoogleDrive/arbor/writing/material/general_result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SNP_CALLING_DATA!$B$2</c:f>
              <c:strCache>
                <c:ptCount val="1"/>
                <c:pt idx="0">
                  <c:v>HOM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SNP_CALLING_DATA!$B$3:$B$50</c:f>
              <c:numCache>
                <c:formatCode>General</c:formatCode>
                <c:ptCount val="48"/>
                <c:pt idx="0">
                  <c:v>367531</c:v>
                </c:pt>
                <c:pt idx="1">
                  <c:v>410627</c:v>
                </c:pt>
                <c:pt idx="2">
                  <c:v>494964</c:v>
                </c:pt>
                <c:pt idx="3">
                  <c:v>366645</c:v>
                </c:pt>
                <c:pt idx="4">
                  <c:v>387804</c:v>
                </c:pt>
                <c:pt idx="5">
                  <c:v>443576</c:v>
                </c:pt>
                <c:pt idx="6">
                  <c:v>402908</c:v>
                </c:pt>
                <c:pt idx="7">
                  <c:v>503695</c:v>
                </c:pt>
                <c:pt idx="8">
                  <c:v>540542</c:v>
                </c:pt>
                <c:pt idx="9">
                  <c:v>429570</c:v>
                </c:pt>
                <c:pt idx="10">
                  <c:v>361946</c:v>
                </c:pt>
                <c:pt idx="11">
                  <c:v>512853</c:v>
                </c:pt>
                <c:pt idx="12">
                  <c:v>386694</c:v>
                </c:pt>
                <c:pt idx="13">
                  <c:v>473997</c:v>
                </c:pt>
                <c:pt idx="14">
                  <c:v>478285</c:v>
                </c:pt>
                <c:pt idx="15">
                  <c:v>488303</c:v>
                </c:pt>
                <c:pt idx="16">
                  <c:v>331160</c:v>
                </c:pt>
                <c:pt idx="17">
                  <c:v>447845</c:v>
                </c:pt>
                <c:pt idx="18">
                  <c:v>526288</c:v>
                </c:pt>
                <c:pt idx="19">
                  <c:v>351597</c:v>
                </c:pt>
                <c:pt idx="20">
                  <c:v>305756</c:v>
                </c:pt>
                <c:pt idx="21">
                  <c:v>393685</c:v>
                </c:pt>
                <c:pt idx="22">
                  <c:v>492625</c:v>
                </c:pt>
                <c:pt idx="23">
                  <c:v>463956</c:v>
                </c:pt>
                <c:pt idx="24">
                  <c:v>528442</c:v>
                </c:pt>
                <c:pt idx="25">
                  <c:v>653408</c:v>
                </c:pt>
                <c:pt idx="26">
                  <c:v>460589</c:v>
                </c:pt>
                <c:pt idx="27">
                  <c:v>524110</c:v>
                </c:pt>
                <c:pt idx="28">
                  <c:v>506209</c:v>
                </c:pt>
                <c:pt idx="29">
                  <c:v>485026</c:v>
                </c:pt>
                <c:pt idx="30">
                  <c:v>578711</c:v>
                </c:pt>
                <c:pt idx="31">
                  <c:v>460266</c:v>
                </c:pt>
                <c:pt idx="32">
                  <c:v>1161514</c:v>
                </c:pt>
                <c:pt idx="33">
                  <c:v>986574</c:v>
                </c:pt>
                <c:pt idx="34">
                  <c:v>1119531</c:v>
                </c:pt>
                <c:pt idx="35">
                  <c:v>868217</c:v>
                </c:pt>
                <c:pt idx="36">
                  <c:v>1192070</c:v>
                </c:pt>
                <c:pt idx="37">
                  <c:v>1178036</c:v>
                </c:pt>
                <c:pt idx="38">
                  <c:v>920116</c:v>
                </c:pt>
                <c:pt idx="39">
                  <c:v>468451</c:v>
                </c:pt>
                <c:pt idx="40">
                  <c:v>903031</c:v>
                </c:pt>
                <c:pt idx="41">
                  <c:v>916840</c:v>
                </c:pt>
                <c:pt idx="42">
                  <c:v>895467</c:v>
                </c:pt>
                <c:pt idx="43">
                  <c:v>1001731</c:v>
                </c:pt>
                <c:pt idx="44">
                  <c:v>1002700</c:v>
                </c:pt>
                <c:pt idx="45">
                  <c:v>947672</c:v>
                </c:pt>
                <c:pt idx="46">
                  <c:v>1036533</c:v>
                </c:pt>
                <c:pt idx="47">
                  <c:v>8751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78A-B24D-9498-7983AD7936FA}"/>
            </c:ext>
          </c:extLst>
        </c:ser>
        <c:ser>
          <c:idx val="1"/>
          <c:order val="1"/>
          <c:tx>
            <c:strRef>
              <c:f>SNP_CALLING_DATA!$C$2</c:f>
              <c:strCache>
                <c:ptCount val="1"/>
                <c:pt idx="0">
                  <c:v>HET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val>
            <c:numRef>
              <c:f>SNP_CALLING_DATA!$C$3:$C$50</c:f>
              <c:numCache>
                <c:formatCode>General</c:formatCode>
                <c:ptCount val="48"/>
                <c:pt idx="0">
                  <c:v>270820</c:v>
                </c:pt>
                <c:pt idx="1">
                  <c:v>320665</c:v>
                </c:pt>
                <c:pt idx="2">
                  <c:v>406452</c:v>
                </c:pt>
                <c:pt idx="3">
                  <c:v>276332</c:v>
                </c:pt>
                <c:pt idx="4">
                  <c:v>267383</c:v>
                </c:pt>
                <c:pt idx="5">
                  <c:v>298545</c:v>
                </c:pt>
                <c:pt idx="6">
                  <c:v>304372</c:v>
                </c:pt>
                <c:pt idx="7">
                  <c:v>385875</c:v>
                </c:pt>
                <c:pt idx="8">
                  <c:v>456735</c:v>
                </c:pt>
                <c:pt idx="9">
                  <c:v>354018</c:v>
                </c:pt>
                <c:pt idx="10">
                  <c:v>242340</c:v>
                </c:pt>
                <c:pt idx="11">
                  <c:v>373334</c:v>
                </c:pt>
                <c:pt idx="12">
                  <c:v>266590</c:v>
                </c:pt>
                <c:pt idx="13">
                  <c:v>350752</c:v>
                </c:pt>
                <c:pt idx="14">
                  <c:v>356563</c:v>
                </c:pt>
                <c:pt idx="15">
                  <c:v>390876</c:v>
                </c:pt>
                <c:pt idx="16">
                  <c:v>233206</c:v>
                </c:pt>
                <c:pt idx="17">
                  <c:v>354200</c:v>
                </c:pt>
                <c:pt idx="18">
                  <c:v>412388</c:v>
                </c:pt>
                <c:pt idx="19">
                  <c:v>228714</c:v>
                </c:pt>
                <c:pt idx="20">
                  <c:v>203961</c:v>
                </c:pt>
                <c:pt idx="21">
                  <c:v>280892</c:v>
                </c:pt>
                <c:pt idx="22">
                  <c:v>404411</c:v>
                </c:pt>
                <c:pt idx="23">
                  <c:v>368465</c:v>
                </c:pt>
                <c:pt idx="24">
                  <c:v>421565</c:v>
                </c:pt>
                <c:pt idx="25">
                  <c:v>528384</c:v>
                </c:pt>
                <c:pt idx="26">
                  <c:v>314457</c:v>
                </c:pt>
                <c:pt idx="27">
                  <c:v>403257</c:v>
                </c:pt>
                <c:pt idx="28">
                  <c:v>341126</c:v>
                </c:pt>
                <c:pt idx="29">
                  <c:v>311346</c:v>
                </c:pt>
                <c:pt idx="30">
                  <c:v>479146</c:v>
                </c:pt>
                <c:pt idx="31">
                  <c:v>305405</c:v>
                </c:pt>
                <c:pt idx="32">
                  <c:v>735933</c:v>
                </c:pt>
                <c:pt idx="33">
                  <c:v>642086</c:v>
                </c:pt>
                <c:pt idx="34">
                  <c:v>661039</c:v>
                </c:pt>
                <c:pt idx="35">
                  <c:v>526870</c:v>
                </c:pt>
                <c:pt idx="36">
                  <c:v>747719</c:v>
                </c:pt>
                <c:pt idx="37">
                  <c:v>759083</c:v>
                </c:pt>
                <c:pt idx="38">
                  <c:v>549136</c:v>
                </c:pt>
                <c:pt idx="39">
                  <c:v>511112</c:v>
                </c:pt>
                <c:pt idx="40">
                  <c:v>596675</c:v>
                </c:pt>
                <c:pt idx="41">
                  <c:v>641968</c:v>
                </c:pt>
                <c:pt idx="42">
                  <c:v>606585</c:v>
                </c:pt>
                <c:pt idx="43">
                  <c:v>636798</c:v>
                </c:pt>
                <c:pt idx="44">
                  <c:v>614507</c:v>
                </c:pt>
                <c:pt idx="45">
                  <c:v>591569</c:v>
                </c:pt>
                <c:pt idx="46">
                  <c:v>662188</c:v>
                </c:pt>
                <c:pt idx="47">
                  <c:v>54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78A-B24D-9498-7983AD7936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5"/>
        <c:overlap val="100"/>
        <c:axId val="1784272255"/>
        <c:axId val="1784273903"/>
      </c:barChart>
      <c:catAx>
        <c:axId val="1784272255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it-IT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ample ID</a:t>
                </a:r>
              </a:p>
            </c:rich>
          </c:tx>
          <c:layout>
            <c:manualLayout>
              <c:xMode val="edge"/>
              <c:yMode val="edge"/>
              <c:x val="0.5007678007821148"/>
              <c:y val="0.9486818315972037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1784273903"/>
        <c:crosses val="autoZero"/>
        <c:auto val="1"/>
        <c:lblAlgn val="ctr"/>
        <c:lblOffset val="100"/>
        <c:noMultiLvlLbl val="0"/>
      </c:catAx>
      <c:valAx>
        <c:axId val="178427390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# </a:t>
                </a:r>
                <a:r>
                  <a:rPr lang="it-IT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variants</a:t>
                </a:r>
                <a:endParaRPr lang="it-IT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8.2045182438860876E-3"/>
              <c:y val="0.3625830646591640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it-IT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178427225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C385BA-8E5A-8640-B000-1148B73B9708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0AE31E1-479A-F34F-90B5-0FEEAF0C2B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183791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0AE31E1-479A-F34F-90B5-0FEEAF0C2B70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41944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F3DBD81-52CE-7A49-8CDF-CEE41D6507A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9A5EFE1F-E5FC-F34C-860A-BF04ADD3273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129FB6F-31C0-334A-AAF0-DB3B474D83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1B161-D757-9043-94A7-7ACAD096CAD9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AEDD6E7-EFCF-A645-BDC5-DDB7546FE5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4EE2521-781C-1046-9061-CA11E57B92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0973D-5B54-F54A-8ACE-1043310FEC9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879691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4BD5A94-6405-4D47-942C-12FFC0E9BD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F7A5E7E6-3436-944E-9400-6090B834E7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57E9912-8C4D-C242-A1F7-A7FFD74B86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1B161-D757-9043-94A7-7ACAD096CAD9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F3A6FFA-2C05-1540-96A4-DC1AECC44F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642320B-B99D-D442-A345-604712C708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0973D-5B54-F54A-8ACE-1043310FEC9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357935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4269CC73-20D9-BD48-B40C-6075D40C309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8742DF9F-4561-9B4A-9AE1-348EFDA165A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BD47534-397F-964B-9924-84CF565F6B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1B161-D757-9043-94A7-7ACAD096CAD9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BDA746E-1133-6940-8E9F-A71C6CED65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75DBE42-1E69-DB4B-835C-BCD5A71036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0973D-5B54-F54A-8ACE-1043310FEC9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206734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1A9515B-1EC9-6842-BF46-43E5B0F0C0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FADF4F7D-66CB-5440-9EFB-A88AE68230B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113839C-5CDC-8149-9DD2-2BD31040ED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1B161-D757-9043-94A7-7ACAD096CAD9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3CB519C-C1BA-944C-BAFF-C784C48C17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E0589F9-70C5-F14A-B81B-326C771602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0973D-5B54-F54A-8ACE-1043310FEC9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53671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4B8991C-116B-894F-BF5C-08E9928C8B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9FE740E0-F9EA-DB41-8C14-47ECB44931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AA716EB-A40F-1842-A631-D5B10E223F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1B161-D757-9043-94A7-7ACAD096CAD9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AA43B46-4B31-8A49-B9B7-8A7326964A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002D09A-D76F-934D-AE22-9D8BFA2ED2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0973D-5B54-F54A-8ACE-1043310FEC9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940229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85DDA02-F7EF-F84C-AF18-89B3C3524D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B302C2A-DF9C-0444-B2FC-70F264D9372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B29CC5F9-10B3-D84F-9C09-28D24C2677C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A8F98C5-8AE3-294E-808E-F9AF15D2B7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1B161-D757-9043-94A7-7ACAD096CAD9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8E0C53A4-9F43-3141-B534-4FB8E8CDF1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721432F-B1ED-6845-ADEB-E0DA4F1C4E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0973D-5B54-F54A-8ACE-1043310FEC9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331915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AD53DED-14E3-AA46-B566-CEB30F9D3C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DBB0D9BF-0DFE-4A4D-9F94-B05BB0ACA3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A923207-BDF1-2B40-B920-AACAFE232D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6E22DC07-29F5-9644-9572-4B925C4721F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C6E679A6-B78C-BA41-AEFE-E09B632A13F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A5851D3B-1EEC-154F-AC82-7B0678DD49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1B161-D757-9043-94A7-7ACAD096CAD9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0DA1897D-6F90-C348-851E-12AB129830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313BDE1F-6CEF-B04B-9BA9-8A97BAF88C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0973D-5B54-F54A-8ACE-1043310FEC9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172306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33F54B5-8F06-9145-9354-AC7B7A644C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E2C991A1-4B5D-8A4E-A8C3-97D7E91810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1B161-D757-9043-94A7-7ACAD096CAD9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C524597D-1353-1141-9C1D-9574B33B27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4B0FF7CE-D17A-E248-89D5-77E7EFE6BA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0973D-5B54-F54A-8ACE-1043310FEC9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652504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8D99D776-5976-964F-BA4F-C5F3A42A57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1B161-D757-9043-94A7-7ACAD096CAD9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FA0FCF64-33AF-134E-9B79-1F1AAC9E8F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FD36EA44-D651-1B4E-8E7C-252884A6B4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0973D-5B54-F54A-8ACE-1043310FEC9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484517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974CFDB-9827-FB47-A7E0-8523C3EE2D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C926FE1-CEB0-0640-97EA-F27BD965F18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9EB434DA-ACAB-3D48-BD3E-964D737429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3897713-4E23-7F4D-8FB1-8EC0DBEB23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1B161-D757-9043-94A7-7ACAD096CAD9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91EF83F-142E-CA44-8278-4821F7578D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5892E75-CF3A-9E46-B9D6-D8814E8E3D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0973D-5B54-F54A-8ACE-1043310FEC9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176761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CA1F67A-F72C-0342-A47A-4B2EE73F67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5E0126CC-8317-8F49-81FF-93C48BFAC0A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8ED8AD1F-3091-AD4F-91B8-9C1C985BEE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E6A0CF2F-BD23-4A49-AC84-69BB952EE0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81B161-D757-9043-94A7-7ACAD096CAD9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CE8CAE93-023E-CA49-A0E1-E669648903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0ACE450-DE1D-BE40-82C8-4251D25EAF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D0973D-5B54-F54A-8ACE-1043310FEC9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479535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24E98EAA-7C3F-C446-AE15-4624988DF4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5ABFDFC-F485-D248-97FD-EA44728613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8DC4801-A18A-1E44-A12E-D4D7B63253E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81B161-D757-9043-94A7-7ACAD096CAD9}" type="datetimeFigureOut">
              <a:rPr lang="it-IT" smtClean="0"/>
              <a:t>04/11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1FFD410-B00F-3B49-AB0D-30B40955FE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DC5F78A-2D10-9640-A4E1-18204842C7A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D0973D-5B54-F54A-8ACE-1043310FEC9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549871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Grafico 4">
            <a:extLst>
              <a:ext uri="{FF2B5EF4-FFF2-40B4-BE49-F238E27FC236}">
                <a16:creationId xmlns:a16="http://schemas.microsoft.com/office/drawing/2014/main" id="{FA58BD25-8831-8E40-83EE-51F486E02FE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98818299"/>
              </p:ext>
            </p:extLst>
          </p:nvPr>
        </p:nvGraphicFramePr>
        <p:xfrm>
          <a:off x="678253" y="576102"/>
          <a:ext cx="10835493" cy="57057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CasellaDiTesto 2">
            <a:extLst>
              <a:ext uri="{FF2B5EF4-FFF2-40B4-BE49-F238E27FC236}">
                <a16:creationId xmlns:a16="http://schemas.microsoft.com/office/drawing/2014/main" id="{40D98930-683B-31F2-9CD3-1AE0F63E7C26}"/>
              </a:ext>
            </a:extLst>
          </p:cNvPr>
          <p:cNvSpPr txBox="1"/>
          <p:nvPr/>
        </p:nvSpPr>
        <p:spPr>
          <a:xfrm>
            <a:off x="0" y="6130222"/>
            <a:ext cx="12192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1.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lignment statistics of high-quality reads from 48 bread wheat samples mapped along the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hinese Spring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reference genome. The stacked bar chart shows the percentage of on-target and off-target reads as well as of reads mapped in the regions of 100 or 200 bp in length on each side of exons.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ample 6 =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belde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Sample 34 =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ankaodali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it-IT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832240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93</TotalTime>
  <Words>71</Words>
  <Application>Microsoft Macintosh PowerPoint</Application>
  <PresentationFormat>Widescreen</PresentationFormat>
  <Paragraphs>4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alvatore esposito</dc:creator>
  <cp:lastModifiedBy>Salvatore Esposito</cp:lastModifiedBy>
  <cp:revision>11</cp:revision>
  <dcterms:created xsi:type="dcterms:W3CDTF">2022-02-08T09:07:45Z</dcterms:created>
  <dcterms:modified xsi:type="dcterms:W3CDTF">2022-11-04T13:42:35Z</dcterms:modified>
</cp:coreProperties>
</file>